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7"/>
  </p:notesMasterIdLst>
  <p:sldIdLst>
    <p:sldId id="256" r:id="rId2"/>
    <p:sldId id="263" r:id="rId3"/>
    <p:sldId id="260" r:id="rId4"/>
    <p:sldId id="262" r:id="rId5"/>
    <p:sldId id="267" r:id="rId6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73" d="100"/>
          <a:sy n="73" d="100"/>
        </p:scale>
        <p:origin x="279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Zila Martinez Lozada" userId="ff0e370b-aba8-49c6-b306-92753b7e05d3" providerId="ADAL" clId="{AA5CD94E-E0C6-4BB4-9C15-1AF18328FE0C}"/>
    <pc:docChg chg="delSld modSld">
      <pc:chgData name="Zila Martinez Lozada" userId="ff0e370b-aba8-49c6-b306-92753b7e05d3" providerId="ADAL" clId="{AA5CD94E-E0C6-4BB4-9C15-1AF18328FE0C}" dt="2024-09-27T18:12:56.442" v="28" actId="47"/>
      <pc:docMkLst>
        <pc:docMk/>
      </pc:docMkLst>
      <pc:sldChg chg="modSp mod">
        <pc:chgData name="Zila Martinez Lozada" userId="ff0e370b-aba8-49c6-b306-92753b7e05d3" providerId="ADAL" clId="{AA5CD94E-E0C6-4BB4-9C15-1AF18328FE0C}" dt="2024-09-27T18:12:44.005" v="21" actId="20577"/>
        <pc:sldMkLst>
          <pc:docMk/>
          <pc:sldMk cId="4273976251" sldId="256"/>
        </pc:sldMkLst>
        <pc:spChg chg="mod">
          <ac:chgData name="Zila Martinez Lozada" userId="ff0e370b-aba8-49c6-b306-92753b7e05d3" providerId="ADAL" clId="{AA5CD94E-E0C6-4BB4-9C15-1AF18328FE0C}" dt="2024-09-27T18:12:44.005" v="21" actId="20577"/>
          <ac:spMkLst>
            <pc:docMk/>
            <pc:sldMk cId="4273976251" sldId="256"/>
            <ac:spMk id="3" creationId="{25DDF706-0BC6-4F57-68D1-BD0BA0BA43C9}"/>
          </ac:spMkLst>
        </pc:spChg>
      </pc:sldChg>
      <pc:sldChg chg="del">
        <pc:chgData name="Zila Martinez Lozada" userId="ff0e370b-aba8-49c6-b306-92753b7e05d3" providerId="ADAL" clId="{AA5CD94E-E0C6-4BB4-9C15-1AF18328FE0C}" dt="2024-09-27T18:12:46.545" v="22" actId="47"/>
        <pc:sldMkLst>
          <pc:docMk/>
          <pc:sldMk cId="3890814096" sldId="258"/>
        </pc:sldMkLst>
      </pc:sldChg>
      <pc:sldChg chg="del">
        <pc:chgData name="Zila Martinez Lozada" userId="ff0e370b-aba8-49c6-b306-92753b7e05d3" providerId="ADAL" clId="{AA5CD94E-E0C6-4BB4-9C15-1AF18328FE0C}" dt="2024-09-27T18:12:48.116" v="23" actId="47"/>
        <pc:sldMkLst>
          <pc:docMk/>
          <pc:sldMk cId="3236497374" sldId="259"/>
        </pc:sldMkLst>
      </pc:sldChg>
      <pc:sldChg chg="del">
        <pc:chgData name="Zila Martinez Lozada" userId="ff0e370b-aba8-49c6-b306-92753b7e05d3" providerId="ADAL" clId="{AA5CD94E-E0C6-4BB4-9C15-1AF18328FE0C}" dt="2024-09-27T18:12:50.426" v="24" actId="47"/>
        <pc:sldMkLst>
          <pc:docMk/>
          <pc:sldMk cId="2353679703" sldId="261"/>
        </pc:sldMkLst>
      </pc:sldChg>
      <pc:sldChg chg="del">
        <pc:chgData name="Zila Martinez Lozada" userId="ff0e370b-aba8-49c6-b306-92753b7e05d3" providerId="ADAL" clId="{AA5CD94E-E0C6-4BB4-9C15-1AF18328FE0C}" dt="2024-09-27T18:12:51.917" v="25" actId="47"/>
        <pc:sldMkLst>
          <pc:docMk/>
          <pc:sldMk cId="4200362096" sldId="264"/>
        </pc:sldMkLst>
      </pc:sldChg>
      <pc:sldChg chg="del">
        <pc:chgData name="Zila Martinez Lozada" userId="ff0e370b-aba8-49c6-b306-92753b7e05d3" providerId="ADAL" clId="{AA5CD94E-E0C6-4BB4-9C15-1AF18328FE0C}" dt="2024-09-27T18:12:54.935" v="27" actId="47"/>
        <pc:sldMkLst>
          <pc:docMk/>
          <pc:sldMk cId="1086413373" sldId="266"/>
        </pc:sldMkLst>
      </pc:sldChg>
      <pc:sldChg chg="del">
        <pc:chgData name="Zila Martinez Lozada" userId="ff0e370b-aba8-49c6-b306-92753b7e05d3" providerId="ADAL" clId="{AA5CD94E-E0C6-4BB4-9C15-1AF18328FE0C}" dt="2024-09-27T18:12:56.442" v="28" actId="47"/>
        <pc:sldMkLst>
          <pc:docMk/>
          <pc:sldMk cId="352848819" sldId="269"/>
        </pc:sldMkLst>
      </pc:sldChg>
      <pc:sldChg chg="del">
        <pc:chgData name="Zila Martinez Lozada" userId="ff0e370b-aba8-49c6-b306-92753b7e05d3" providerId="ADAL" clId="{AA5CD94E-E0C6-4BB4-9C15-1AF18328FE0C}" dt="2024-09-27T18:12:52.861" v="26" actId="47"/>
        <pc:sldMkLst>
          <pc:docMk/>
          <pc:sldMk cId="2868845881" sldId="270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DC0DE57-7028-4CF4-9B7A-5FFE8A28F7C8}" type="datetimeFigureOut">
              <a:rPr lang="en-US" smtClean="0"/>
              <a:t>9/27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DE3D4E0-9A8B-4823-88B8-2B0B70B307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78388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Online Resource 1 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GLT1 and the reporter proteins, </a:t>
            </a:r>
            <a:r>
              <a:rPr lang="en-US" sz="1800" i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eGFP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and </a:t>
            </a:r>
            <a:r>
              <a:rPr lang="en-US" sz="1800" i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dT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, are highly enriched in the SVZ early in development.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DE3D4E0-9A8B-4823-88B8-2B0B70B3078A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478800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Online Resource 2 </a:t>
            </a:r>
            <a:r>
              <a:rPr lang="en-US" sz="1800" i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dT</a:t>
            </a:r>
            <a:r>
              <a:rPr lang="en-US" sz="1800" i="1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+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cells migrate postnatally, while the </a:t>
            </a:r>
            <a:r>
              <a:rPr lang="en-US" sz="1800" i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eGFP</a:t>
            </a:r>
            <a:r>
              <a:rPr lang="en-US" sz="1800" i="1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+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cells remain stationary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DE3D4E0-9A8B-4823-88B8-2B0B70B3078A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56636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Online Resource 3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Expression of striatal neurons canonical markers &amp; GFP and </a:t>
            </a:r>
            <a:r>
              <a:rPr lang="en-US" sz="1800" i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dT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are expressed by different cell types at postnatal day 1, based on </a:t>
            </a:r>
            <a:r>
              <a:rPr lang="en-US" sz="1800" i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c-RNAseq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.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DE3D4E0-9A8B-4823-88B8-2B0B70B3078A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067015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Online Resource 6 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Glutamate signaling regulates the migration of the </a:t>
            </a:r>
            <a:r>
              <a:rPr lang="en-US" sz="1800" i="1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dT</a:t>
            </a:r>
            <a:r>
              <a:rPr lang="en-US" sz="1800" i="1" baseline="300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+ </a:t>
            </a:r>
            <a:r>
              <a:rPr lang="en-US" sz="1800" i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cells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DE3D4E0-9A8B-4823-88B8-2B0B70B3078A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4575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4F6408-B7E1-4660-8FE8-9B6B59C29086}" type="datetimeFigureOut">
              <a:rPr lang="en-US" smtClean="0"/>
              <a:t>9/2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7737D-4151-4ADD-BA43-4A311B05F6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46207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4F6408-B7E1-4660-8FE8-9B6B59C29086}" type="datetimeFigureOut">
              <a:rPr lang="en-US" smtClean="0"/>
              <a:t>9/2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7737D-4151-4ADD-BA43-4A311B05F6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9419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4F6408-B7E1-4660-8FE8-9B6B59C29086}" type="datetimeFigureOut">
              <a:rPr lang="en-US" smtClean="0"/>
              <a:t>9/2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7737D-4151-4ADD-BA43-4A311B05F6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07917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4F6408-B7E1-4660-8FE8-9B6B59C29086}" type="datetimeFigureOut">
              <a:rPr lang="en-US" smtClean="0"/>
              <a:t>9/2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7737D-4151-4ADD-BA43-4A311B05F6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50011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4F6408-B7E1-4660-8FE8-9B6B59C29086}" type="datetimeFigureOut">
              <a:rPr lang="en-US" smtClean="0"/>
              <a:t>9/2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7737D-4151-4ADD-BA43-4A311B05F6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89862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4F6408-B7E1-4660-8FE8-9B6B59C29086}" type="datetimeFigureOut">
              <a:rPr lang="en-US" smtClean="0"/>
              <a:t>9/2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7737D-4151-4ADD-BA43-4A311B05F6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2448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4F6408-B7E1-4660-8FE8-9B6B59C29086}" type="datetimeFigureOut">
              <a:rPr lang="en-US" smtClean="0"/>
              <a:t>9/27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7737D-4151-4ADD-BA43-4A311B05F6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42547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4F6408-B7E1-4660-8FE8-9B6B59C29086}" type="datetimeFigureOut">
              <a:rPr lang="en-US" smtClean="0"/>
              <a:t>9/27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7737D-4151-4ADD-BA43-4A311B05F6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95923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4F6408-B7E1-4660-8FE8-9B6B59C29086}" type="datetimeFigureOut">
              <a:rPr lang="en-US" smtClean="0"/>
              <a:t>9/27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7737D-4151-4ADD-BA43-4A311B05F6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96623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4F6408-B7E1-4660-8FE8-9B6B59C29086}" type="datetimeFigureOut">
              <a:rPr lang="en-US" smtClean="0"/>
              <a:t>9/2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7737D-4151-4ADD-BA43-4A311B05F6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26224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4F6408-B7E1-4660-8FE8-9B6B59C29086}" type="datetimeFigureOut">
              <a:rPr lang="en-US" smtClean="0"/>
              <a:t>9/2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7737D-4151-4ADD-BA43-4A311B05F6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25199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A4F6408-B7E1-4660-8FE8-9B6B59C29086}" type="datetimeFigureOut">
              <a:rPr lang="en-US" smtClean="0"/>
              <a:t>9/2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8D7737D-4151-4ADD-BA43-4A311B05F6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15786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8976DC-AFD0-CE94-843A-0DD0E83FD132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rmAutofit fontScale="90000"/>
          </a:bodyPr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Identification of a Subpopulation of Astrocyte Progenitor Cells in the Neonatal Subventricular Zone: Evidence that Migration is Regulated by Glutamate Signaling </a:t>
            </a:r>
            <a:b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</a:b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 </a:t>
            </a:r>
            <a:b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</a:br>
            <a:endParaRPr lang="en-US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5DDF706-0BC6-4F57-68D1-BD0BA0BA43C9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Supplementary material</a:t>
            </a:r>
          </a:p>
        </p:txBody>
      </p:sp>
    </p:spTree>
    <p:extLst>
      <p:ext uri="{BB962C8B-B14F-4D97-AF65-F5344CB8AC3E}">
        <p14:creationId xmlns:p14="http://schemas.microsoft.com/office/powerpoint/2010/main" val="42739762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1C11017-A21E-26ED-E6A2-12116DA41721}"/>
              </a:ext>
            </a:extLst>
          </p:cNvPr>
          <p:cNvSpPr txBox="1"/>
          <p:nvPr/>
        </p:nvSpPr>
        <p:spPr>
          <a:xfrm>
            <a:off x="246744" y="149161"/>
            <a:ext cx="34689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Online Resource 1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1AADD1D5-4CCD-BC18-040D-C011AE9CE4D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5223" y="518493"/>
            <a:ext cx="6447554" cy="83438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194187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E3D8113C-1DB7-B11E-FF95-25E4E00F8A58}"/>
              </a:ext>
            </a:extLst>
          </p:cNvPr>
          <p:cNvSpPr txBox="1"/>
          <p:nvPr/>
        </p:nvSpPr>
        <p:spPr>
          <a:xfrm>
            <a:off x="246744" y="149161"/>
            <a:ext cx="34689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Online Resource 2</a:t>
            </a:r>
          </a:p>
        </p:txBody>
      </p:sp>
      <p:pic>
        <p:nvPicPr>
          <p:cNvPr id="6" name="Picture 5" descr="A close-up of a microscope">
            <a:extLst>
              <a:ext uri="{FF2B5EF4-FFF2-40B4-BE49-F238E27FC236}">
                <a16:creationId xmlns:a16="http://schemas.microsoft.com/office/drawing/2014/main" id="{5CBCF611-C621-26A7-6266-A26FD485421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99" r="22115" b="36753"/>
          <a:stretch/>
        </p:blipFill>
        <p:spPr>
          <a:xfrm>
            <a:off x="754744" y="773099"/>
            <a:ext cx="5094513" cy="561318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468605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5A9493D-82D0-400F-1EF4-41B01D835E2F}"/>
              </a:ext>
            </a:extLst>
          </p:cNvPr>
          <p:cNvSpPr txBox="1"/>
          <p:nvPr/>
        </p:nvSpPr>
        <p:spPr>
          <a:xfrm>
            <a:off x="246744" y="149161"/>
            <a:ext cx="34689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Online Resource 3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8754953C-765B-EFCE-5E9C-723C3EC7E20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0267" y="683751"/>
            <a:ext cx="6537465" cy="84602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469928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A695512-5379-CC5E-72F6-C3486C68D36B}"/>
              </a:ext>
            </a:extLst>
          </p:cNvPr>
          <p:cNvSpPr txBox="1"/>
          <p:nvPr/>
        </p:nvSpPr>
        <p:spPr>
          <a:xfrm>
            <a:off x="246744" y="149161"/>
            <a:ext cx="34689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Online Resource 6</a:t>
            </a:r>
          </a:p>
        </p:txBody>
      </p:sp>
      <p:pic>
        <p:nvPicPr>
          <p:cNvPr id="4" name="Picture 3" descr="A close-up of a screen">
            <a:extLst>
              <a:ext uri="{FF2B5EF4-FFF2-40B4-BE49-F238E27FC236}">
                <a16:creationId xmlns:a16="http://schemas.microsoft.com/office/drawing/2014/main" id="{04716E51-FB9C-42F4-440E-B671F3E1B98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9322"/>
          <a:stretch/>
        </p:blipFill>
        <p:spPr>
          <a:xfrm>
            <a:off x="0" y="787619"/>
            <a:ext cx="6858000" cy="36102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518773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2c2b2d31-2e3e-4df1-b571-fb37c042ff1b}" enabled="0" method="" siteId="{2c2b2d31-2e3e-4df1-b571-fb37c042ff1b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60</TotalTime>
  <Words>125</Words>
  <Application>Microsoft Office PowerPoint</Application>
  <PresentationFormat>Letter Paper (8.5x11 in)</PresentationFormat>
  <Paragraphs>14</Paragraphs>
  <Slides>5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ptos</vt:lpstr>
      <vt:lpstr>Aptos Display</vt:lpstr>
      <vt:lpstr>Arial</vt:lpstr>
      <vt:lpstr>Times New Roman</vt:lpstr>
      <vt:lpstr>Office Theme</vt:lpstr>
      <vt:lpstr>Identification of a Subpopulation of Astrocyte Progenitor Cells in the Neonatal Subventricular Zone: Evidence that Migration is Regulated by Glutamate Signaling    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dentification of a Subpopulation of Astrocyte Progenitor Cells in the Neonatal Subventricular Zone: Evidence that Migration is Regulated by Glutamate Signaling    </dc:title>
  <dc:creator>Zila Martinez Lozada</dc:creator>
  <cp:lastModifiedBy>Zila Martinez Lozada</cp:lastModifiedBy>
  <cp:revision>4</cp:revision>
  <dcterms:created xsi:type="dcterms:W3CDTF">2024-08-17T20:59:11Z</dcterms:created>
  <dcterms:modified xsi:type="dcterms:W3CDTF">2024-09-27T18:13:03Z</dcterms:modified>
</cp:coreProperties>
</file>